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270033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552" y="20622"/>
      </p:cViewPr>
      <p:guideLst>
        <p:guide orient="horz" pos="850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8388551"/>
            <a:ext cx="7772400" cy="578822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15301912"/>
            <a:ext cx="6400800" cy="690086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5035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724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4256786"/>
            <a:ext cx="2057400" cy="9072383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256786"/>
            <a:ext cx="6019800" cy="9072383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3158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1722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7352171"/>
            <a:ext cx="7772400" cy="536317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11445185"/>
            <a:ext cx="7772400" cy="590698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51542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4809355"/>
            <a:ext cx="4038600" cy="7017127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4809355"/>
            <a:ext cx="4038600" cy="7017127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22369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081387"/>
            <a:ext cx="8229600" cy="450056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6044507"/>
            <a:ext cx="4040188" cy="25190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8563570"/>
            <a:ext cx="4040188" cy="1555819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6044507"/>
            <a:ext cx="4041775" cy="25190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8563570"/>
            <a:ext cx="4041775" cy="1555819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3919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4586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3044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1075134"/>
            <a:ext cx="3008313" cy="45755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1075137"/>
            <a:ext cx="5111750" cy="2304663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5650708"/>
            <a:ext cx="3008313" cy="1847106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749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18902362"/>
            <a:ext cx="5486400" cy="223153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2412802"/>
            <a:ext cx="5486400" cy="162020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21133893"/>
            <a:ext cx="5486400" cy="316914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7257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081387"/>
            <a:ext cx="8229600" cy="4500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6300790"/>
            <a:ext cx="8229600" cy="178209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25028130"/>
            <a:ext cx="2133600" cy="14376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D6733-EDAE-4A24-8D1B-D6C7720A975D}" type="datetimeFigureOut">
              <a:rPr lang="en-AU" smtClean="0"/>
              <a:t>21/0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25028130"/>
            <a:ext cx="2895600" cy="14376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25028130"/>
            <a:ext cx="2133600" cy="14376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21AF9-0D43-415C-AA42-5A7373AFF1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9664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23484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19318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168" y="2782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54" y="4589730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71" y="2275702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653" y="4601951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9888" y="228991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/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3545" y="228991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/>
          <p:cNvPicPr/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2418" y="4589730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/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63" y="6788070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/>
          <p:cNvPicPr/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5211" y="6766149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/>
          <p:cNvPicPr/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4555" y="6771178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/>
          <p:cNvPicPr/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71" y="8956818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/>
          <p:cNvPicPr/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9661" y="8956818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Picture 17"/>
          <p:cNvPicPr/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52" y="13350323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Picture 18"/>
          <p:cNvPicPr/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7389" y="8964433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Picture 19"/>
          <p:cNvPicPr/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294" y="11162674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/>
          <p:cNvPicPr/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3053" y="11163492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/>
          <p:cNvPicPr/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7389" y="11156175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Picture 22"/>
          <p:cNvPicPr/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5013" y="13340798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Picture 23"/>
          <p:cNvPicPr/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689" y="13324997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Picture 24"/>
          <p:cNvPicPr/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68" y="1557304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Picture 25"/>
          <p:cNvPicPr/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7537" y="1556669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Picture 26"/>
          <p:cNvPicPr/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57" y="19970941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Picture 27"/>
          <p:cNvPicPr/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4" y="22196789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Picture 28"/>
          <p:cNvPicPr/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6835" y="22191894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Picture 29"/>
          <p:cNvPicPr/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6326" y="22190489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1" name="Picture 30"/>
          <p:cNvPicPr/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2" y="24402621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Picture 31"/>
          <p:cNvPicPr/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824" y="24378287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3" name="Picture 32"/>
          <p:cNvPicPr/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9927" y="24371937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4" name="Picture 33"/>
          <p:cNvPicPr/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1840" y="15543652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5" name="Picture 34"/>
          <p:cNvPicPr/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13" y="17764093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6" name="Picture 35"/>
          <p:cNvPicPr/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4432" y="17749285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7" name="Picture 36"/>
          <p:cNvPicPr/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7695" y="17753030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8" name="Picture 37"/>
          <p:cNvPicPr/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9" y="19971586"/>
            <a:ext cx="2939107" cy="2194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39" name="Picture 38"/>
          <p:cNvPicPr/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6229" y="19971586"/>
            <a:ext cx="2939107" cy="219414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166812" y="26507043"/>
            <a:ext cx="89644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/>
              <a:t>Additional File 6</a:t>
            </a:r>
            <a:r>
              <a:rPr lang="de-DE" sz="1200" dirty="0" smtClean="0"/>
              <a:t>. </a:t>
            </a:r>
            <a:r>
              <a:rPr lang="en-AU" sz="1200" dirty="0"/>
              <a:t>Estimated mean </a:t>
            </a:r>
            <a:r>
              <a:rPr lang="en-AU" sz="1200" dirty="0" smtClean="0"/>
              <a:t>blood leukocyte levels </a:t>
            </a:r>
            <a:r>
              <a:rPr lang="en-AU" sz="1200" dirty="0"/>
              <a:t>(with 95% confidence intervals) in patients undergoing chemotherapy (green lines) or without chemotherapy (blue lines) at baseline and after 3 and 12 months following therapy initiation.</a:t>
            </a:r>
          </a:p>
        </p:txBody>
      </p:sp>
    </p:spTree>
    <p:extLst>
      <p:ext uri="{BB962C8B-B14F-4D97-AF65-F5344CB8AC3E}">
        <p14:creationId xmlns:p14="http://schemas.microsoft.com/office/powerpoint/2010/main" val="3808654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Shipp</dc:creator>
  <cp:lastModifiedBy>Christopher Shipp</cp:lastModifiedBy>
  <cp:revision>8</cp:revision>
  <dcterms:created xsi:type="dcterms:W3CDTF">2016-09-19T11:28:27Z</dcterms:created>
  <dcterms:modified xsi:type="dcterms:W3CDTF">2017-01-21T15:22:57Z</dcterms:modified>
</cp:coreProperties>
</file>